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28DDE-1740-47BE-BBB8-F22C2C8C51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7C7F5-1065-4F93-820B-E1EAF38AC1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DD3FA6-31B0-4F36-B186-A5B38ECC43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FDEB1-5042-4A79-95B3-6FBEDA636A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95327C-47C9-44DD-ABB2-EC4E06F9ED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7D7A4-8C47-4D4D-9E62-9407C52A44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71D32-5263-4E9A-85A9-ACEC9F1F4F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2C7F2-5711-4D17-8B4F-597514A0C8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BA5AE6-F397-43A8-A29E-DB90BB8AFE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400B9C-64CC-4976-AEBC-56A7191CA4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59551-B936-44E9-A533-F93A2F91F0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079FCD-1DFE-439E-8E95-58C7AF1C38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C3247C-EE72-4BCE-A378-F05AEF2ACF9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57120" y="428760"/>
          <a:ext cx="8501040" cy="6000480"/>
        </p:xfrm>
        <a:graphic>
          <a:graphicData uri="http://schemas.openxmlformats.org/drawingml/2006/table">
            <a:tbl>
              <a:tblPr/>
              <a:tblGrid>
                <a:gridCol w="311040"/>
                <a:gridCol w="486000"/>
                <a:gridCol w="684000"/>
                <a:gridCol w="611280"/>
                <a:gridCol w="3333960"/>
                <a:gridCol w="666720"/>
                <a:gridCol w="468360"/>
                <a:gridCol w="676080"/>
                <a:gridCol w="1263600"/>
              </a:tblGrid>
              <a:tr h="155880">
                <a:tc gridSpan="5">
                  <a:txBody>
                    <a:bodyPr lIns="41760" rIns="417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4.  Summary of proteins identified by MALDI-TOF-M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1760" rIns="417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75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ot no.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 Ratio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CBI accesion no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eoretical pI/M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OR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 coverage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unction*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824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5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5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yruvate dehydrogenase E1 component oxidoreductase protein Ace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9/1010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07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5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5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yruvate dehydrogenase E1 component oxidoreductase protein Ace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9/1010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7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7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pB protein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49/957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apero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5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7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7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pB protein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49/957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apero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7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7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pB protein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49/957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apero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07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719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7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reonyl tRNA synth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9/738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5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33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3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-gulono-gamma-lactone oxid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9/713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33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3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-gulono-gamma-lactone oxid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9/713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086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2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2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urine NTPase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4/677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07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3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3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aperone Hsp90 HtpG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46/710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apero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4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3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rocanate hydrat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8/610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5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9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9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late dehydrogenase (NAD-linked), malic enzym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13/618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9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9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late dehydrogenase (NAD-linked), malic enzym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13/618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07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2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2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ccinate semialdehyde dehydrogen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63/516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5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2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2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ycine betaine aldehyde dehydrogen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2/529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00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5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48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048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3/560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"/>
          <p:cNvGraphicFramePr/>
          <p:nvPr/>
        </p:nvGraphicFramePr>
        <p:xfrm>
          <a:off x="357120" y="214200"/>
          <a:ext cx="8572680" cy="6286680"/>
        </p:xfrm>
        <a:graphic>
          <a:graphicData uri="http://schemas.openxmlformats.org/drawingml/2006/table">
            <a:tbl>
              <a:tblPr/>
              <a:tblGrid>
                <a:gridCol w="316080"/>
                <a:gridCol w="490320"/>
                <a:gridCol w="671760"/>
                <a:gridCol w="615960"/>
                <a:gridCol w="3408120"/>
                <a:gridCol w="639720"/>
                <a:gridCol w="471600"/>
                <a:gridCol w="681120"/>
                <a:gridCol w="1278000"/>
              </a:tblGrid>
              <a:tr h="489240">
                <a:tc gridSpan="3"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br>
                        <a:rPr sz="900"/>
                      </a:b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4. (continu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440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ot no.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 Ratio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CBI accesion no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eoretical pI/M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OR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 coverage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unction*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636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19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1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yruvate kinase II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82/516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7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7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osine-5'-monophosphate dehydroge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8/525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2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1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mine oxidase, flavin contain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6/558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3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3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peridine-6-carboxylate dehydroge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1/552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4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3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3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peridine-6-carboxylate dehydroge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1/552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636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3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3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peridine-6-carboxylate dehydroge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1/552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1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1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thylmalonate-semialdehyde dehydroge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6/552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8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8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ccinyl-diaminopimelate desuccinyl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57/524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7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7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gma 54-dependent response regulat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31/509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anscription regulat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636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6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6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06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1/507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6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6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06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1/507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6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5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iolase (acetyl-CoA acetyltransferase 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72/470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0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9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mbrane protein, Tfp pilus assembly, pilus retraction ATPase Pil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62/497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tilit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636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8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8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yl CoA C-acetyltransfer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6/411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8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8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yl CoA C-acetyltransfer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6/411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9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9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-dehydroquinate synthet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5/409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0680" rIns="4068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0680" marR="40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285840" y="428760"/>
          <a:ext cx="8501040" cy="6000480"/>
        </p:xfrm>
        <a:graphic>
          <a:graphicData uri="http://schemas.openxmlformats.org/drawingml/2006/table">
            <a:tbl>
              <a:tblPr/>
              <a:tblGrid>
                <a:gridCol w="312480"/>
                <a:gridCol w="486000"/>
                <a:gridCol w="666720"/>
                <a:gridCol w="611280"/>
                <a:gridCol w="3379680"/>
                <a:gridCol w="633240"/>
                <a:gridCol w="468360"/>
                <a:gridCol w="677880"/>
                <a:gridCol w="1265400"/>
              </a:tblGrid>
              <a:tr h="299880">
                <a:tc gridSpan="3"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4. (continu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5084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ot no.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 Ratio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CBI accesion no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eoretical pI/M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OR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 coverage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unction*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024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3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3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-ketoacyl CoA thiolase (acetyl-CoA acetyltransferase 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7/422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9988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3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3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-ketoacyl CoA thiolase (acetyl-CoA acetyltransferase 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7/422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024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5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4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do-1,4 beta-gluca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73/423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988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2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2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-hydroxyphenylpyruvate dioxygen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7/405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988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9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8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-hydroxyisobutyryl Coenzyme A hydrol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66/388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024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4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39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039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9/395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988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7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7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ginine/ornithine succinyltransfer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05/395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024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2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2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cohol dehydrogenase, iron contain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8/415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4928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9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9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digoidine synthase A-like protein, uncharacterized enzyme involved in pigment biosynthesi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9/335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xin production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988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22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2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inc binding dehydroge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5/371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024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22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2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inc binding dehydroge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5/371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988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9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8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p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33/355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024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7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7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lagellar motor switch protein Fli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97/366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tilit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988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9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9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-oxoglutarate ferredoxin oxidoreductase beta subunit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39/370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9880"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906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8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p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33/355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5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2840" rIns="4284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2840" marR="42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285840" y="357120"/>
          <a:ext cx="8572320" cy="6000840"/>
        </p:xfrm>
        <a:graphic>
          <a:graphicData uri="http://schemas.openxmlformats.org/drawingml/2006/table">
            <a:tbl>
              <a:tblPr/>
              <a:tblGrid>
                <a:gridCol w="315720"/>
                <a:gridCol w="490680"/>
                <a:gridCol w="671400"/>
                <a:gridCol w="615960"/>
                <a:gridCol w="3408480"/>
                <a:gridCol w="639720"/>
                <a:gridCol w="471600"/>
                <a:gridCol w="684000"/>
                <a:gridCol w="1274760"/>
              </a:tblGrid>
              <a:tr h="355680">
                <a:tc gridSpan="3"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br>
                        <a:rPr sz="900"/>
                      </a:b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4. (continu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0324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ot no.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 Ratio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CBI accesion no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eoretical pI/M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OR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 coverage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unction*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804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9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9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ystathionine beta synth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6/343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257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8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8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lysialic acid capsule expression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/343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48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8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8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28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7/334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84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8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8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28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7/334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53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8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8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droxymethylglutaryl-CoA ly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/327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48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6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6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DP-N-acetylenolpyruvoylglucosamine reduct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6/339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57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4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4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urine nucleoside phosphorylase 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/321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804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15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1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11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69/287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48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7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7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ptum site-determining protein MinD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8/301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tilit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84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5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5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do/keto reductases, related to diketogulonate reduct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35/323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804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6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6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2678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85/302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7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6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etoacetate decarboxylase ADC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43/283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804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0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9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099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46/317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6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6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ienelactone hydrolase family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38/274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804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5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5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ccinate dehydrogenase iron-sulfur protein subunit B (succinate dehydrogenase catalytic subuni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18/273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"/>
          <p:cNvGraphicFramePr/>
          <p:nvPr/>
        </p:nvGraphicFramePr>
        <p:xfrm>
          <a:off x="357120" y="357120"/>
          <a:ext cx="8286840" cy="6143760"/>
        </p:xfrm>
        <a:graphic>
          <a:graphicData uri="http://schemas.openxmlformats.org/drawingml/2006/table">
            <a:tbl>
              <a:tblPr/>
              <a:tblGrid>
                <a:gridCol w="304920"/>
                <a:gridCol w="474480"/>
                <a:gridCol w="649440"/>
                <a:gridCol w="595440"/>
                <a:gridCol w="3294000"/>
                <a:gridCol w="619200"/>
                <a:gridCol w="455400"/>
                <a:gridCol w="660600"/>
                <a:gridCol w="1233360"/>
              </a:tblGrid>
              <a:tr h="223920">
                <a:tc gridSpan="3"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4. (continu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9388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ot no.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 Ratio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CBI accesion no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eoretical pI/M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OR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 coverage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unction*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212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9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8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-hydroxyisobutyryl Coenzyme A hydrol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5/276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8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8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18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85/253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66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8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8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18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85/253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248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9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8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-hydroxyisobutyryl Coenzyme A hydrol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5/276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35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3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2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NA-binding response regulat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/251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anscription regulat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6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5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etyoacetyl CoA reduct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1/269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4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2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2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racil phosphoribosyltransfer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19/238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6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5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hosphate transport regulat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4/254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0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0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etoacetyl CoA reduct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53/292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2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275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2275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19/263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66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8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79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crophage infectivity potentiator (Mip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19/251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xin production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9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9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lagella basal body P-ring formation protein FlgA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22/260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tilit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8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79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crophage infectivity potentiator (Mip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19/251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xin production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6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5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etyoacetyl CoA reducta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85/273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9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9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09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1/253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2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2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ort chain dehydroge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12/211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760" rIns="417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1760" marR="41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"/>
          <p:cNvGraphicFramePr/>
          <p:nvPr/>
        </p:nvGraphicFramePr>
        <p:xfrm>
          <a:off x="428760" y="500040"/>
          <a:ext cx="8143920" cy="3971880"/>
        </p:xfrm>
        <a:graphic>
          <a:graphicData uri="http://schemas.openxmlformats.org/drawingml/2006/table">
            <a:tbl>
              <a:tblPr/>
              <a:tblGrid>
                <a:gridCol w="438120"/>
                <a:gridCol w="455400"/>
                <a:gridCol w="635040"/>
                <a:gridCol w="576360"/>
                <a:gridCol w="3217680"/>
                <a:gridCol w="625680"/>
                <a:gridCol w="636480"/>
                <a:gridCol w="701640"/>
                <a:gridCol w="857520"/>
              </a:tblGrid>
              <a:tr h="137520">
                <a:tc gridSpan="3"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4. (continu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ot no.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 Ratio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CBI accesion no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eoretical pI/M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OR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 coverage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unction***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9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9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racellular protease, ThiJ/PfpI family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55/220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3184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4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4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DPH-dependent FMN reductase domain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85/205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108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56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1647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tical protein lpg1647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06/223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1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1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d related protein-like (SDe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88/1696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strate of Icm/Do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188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1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1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d related protein-like (SDeC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5/1722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strate of Icm/Do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48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1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1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d related protein-like (SDeC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5/1722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strate of Icm/Do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48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61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21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d related protein-like (SDeC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5/1722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strate of Icm/Do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48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2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2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d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5/1715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strate of Icm/Do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2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2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d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5/1715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strate of Icm/Do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6280"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P_0942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g02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d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5/1715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strate of Icm/Do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7520">
                <a:tc gridSpan="5"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Spot No. indicate the circle numbers in 2D-DIGE gel image (Fig. 1)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 gridSpan="6"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Ratio means the ratio of the protein spot intensity at PE to that at E; PE/E.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520">
                <a:tc gridSpan="6" rowSpan="2">
                  <a:txBody>
                    <a:bodyPr lIns="11160" rIns="1116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*Sequence coverage means the ratio of the number of identified amino acid sequence to that of the actual whole amino acid sequence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520">
                <a:tc gridSpan="5"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***Function was assigned based on functions indicated in NCBInr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20T06:10:40Z</dcterms:created>
  <dc:creator>Tsuyoshi</dc:creator>
  <dc:description/>
  <dc:language>en-US</dc:language>
  <cp:lastModifiedBy>MiyakeMasaki</cp:lastModifiedBy>
  <dcterms:modified xsi:type="dcterms:W3CDTF">2010-03-02T01:27:37Z</dcterms:modified>
  <cp:revision>27</cp:revision>
  <dc:subject/>
  <dc:title>スライド 1</dc:title>
</cp:coreProperties>
</file>